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5" r:id="rId4"/>
    <p:sldId id="263" r:id="rId5"/>
    <p:sldId id="264" r:id="rId6"/>
    <p:sldId id="266" r:id="rId7"/>
    <p:sldId id="267" r:id="rId8"/>
    <p:sldId id="268" r:id="rId9"/>
    <p:sldId id="258" r:id="rId10"/>
    <p:sldId id="269" r:id="rId11"/>
    <p:sldId id="262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9" d="100"/>
          <a:sy n="39" d="100"/>
        </p:scale>
        <p:origin x="20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60AD97-CFA5-492A-89C6-6736A473BB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DB8505C-8E97-49B8-993F-CDBF59FECF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E3C5F6-2195-4301-A000-120D44675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684DCE-D52B-4274-9ECD-45F2A0FD5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027701-6C3B-4D3B-A2FF-29C8DFAE8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188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26E932-5307-4B4D-89C4-E298D69F57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C43DA46-B190-41D9-AC0E-C0798929F4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CA0F01-CD5E-46DA-8586-94AD8A119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36001B-3CBE-4E7A-9D12-BD2861CE8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D59448-F4E5-4B6B-96D5-7DA14CB17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8557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D70B197-6FA4-451A-A78C-B7BEA9F0CF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EDE2591-3FA0-4FEA-877B-5ABE0527EF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DCB659-0215-4B3B-B06F-1857C0080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2593F2-4401-492D-87EA-2EEA15619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25B25E-B540-4E5E-89FA-00E310DB9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997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E1CEAC-2E4D-49F1-B0EE-8D7E822F5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233605-378D-4234-8585-4D9129D00D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8D6764-C09C-4C76-8B59-8AA0EA10A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388CA4-C036-4656-9501-DCAA892B2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D1A8BB-9D36-436A-B221-1ED33DE63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729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406532-60D3-4DC4-8F63-6616503E4C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4B48DC-15EF-4E1F-9551-EA0BC50C27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51417C-AF80-47B6-B2F4-2903E2775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D61067-BE82-4760-8975-B3698CA00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CFB181-5203-43B6-9F75-4D1FBB02B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0466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29698D-FAC4-4A63-84A2-25B65F979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B5CA2C3-F006-4A0D-9D7B-6003796582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6D997B8-21C6-4CFE-80BC-7FA0C098FF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B1B1EF-BB0F-4934-8BF3-83FADC152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209664-C45D-4443-AB33-85FF9E122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A35DD05-1094-4082-9874-CFF924EE2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2432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85F985-39C4-4120-8F3E-21DB218660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F32451-FD8C-4432-9569-D117BCADAD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9DE3BEE-351B-4148-9434-4755E5904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CEFF32-7F86-4680-B24A-3D2B4354AC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BD63094-49A1-4FDD-844F-A20A7B04CA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4BEC7CF-9B10-4CD8-928C-5FBC3B910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8B91EEE-DC5D-4514-9FA7-5503C9714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AA115F-904A-49EA-AABC-FCA737E55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319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D6801-D657-43B5-AFDA-0E0263C5D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FB2E3AB-774F-49F2-9149-AC3B5DB4C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C4E212E-705E-4BF3-B0A8-2A13D708B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96CF5AC-CB09-4562-9FAE-1918E982D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3031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FC7A4D1-F740-4DB8-9D16-949ACCB38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2E3EDB6-2685-434F-B4EC-7E6080069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EB28C83-7E84-4967-AE2D-BDE6D92FB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734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A5B186-4F64-4D95-8EAE-01B97F1993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D3AA17D-9C04-46D8-80B9-EEA6DA70D8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5877B0-A5A2-405F-A8AF-C453068C0C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8CECF8-3735-4CFC-A63F-45FC5C417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E3E51C-29DE-4136-A62C-DD19A7A2E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D045C1-50E6-4CAE-A675-DD0277659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5645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BE4DB8-F47D-4E3B-8651-62964A403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A57875-9B87-420B-AC6D-16962828F9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C5A79F-BAA9-4A04-997B-50C306BAFA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A2F09A-F10E-4A36-BA79-A4020F8D2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A2CCD12-1BD1-48D0-86D1-94C1511C5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4C6D8C-5900-4B00-BF91-96032774A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284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FA6FC3-94FF-436B-B944-CE05ADB33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60F54E-7DC2-4019-8B8A-74ED7DDE7B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FF383A-A8B9-4235-A143-FBF19C1269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50E49-C3B1-4562-B1B1-A4F9C3304EE9}" type="datetimeFigureOut">
              <a:rPr lang="zh-CN" altLang="en-US" smtClean="0"/>
              <a:t>2022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79853F-5C89-4E02-8BBC-7A669A3B8A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2351AE-8DA5-4CD1-8ECE-080A19ACA1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FEC38-AF2A-42EE-B2C7-817E958D99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6279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040BA1-039F-4CBD-903D-E582B95B5C1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ediction of these 8 genes by TMHM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FA79EA0-F02E-4ADB-BA78-A452D9C8C90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85494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97CBF759-63AE-4ECF-B237-50205E8CB3C3}"/>
              </a:ext>
            </a:extLst>
          </p:cNvPr>
          <p:cNvSpPr/>
          <p:nvPr/>
        </p:nvSpPr>
        <p:spPr>
          <a:xfrm>
            <a:off x="224841" y="2801760"/>
            <a:ext cx="11742317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</a:pPr>
            <a:r>
              <a:rPr lang="en-US" altLang="zh-CN" sz="6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he tertiary structure of 8 P450 genes </a:t>
            </a:r>
          </a:p>
          <a:p>
            <a:pPr algn="ctr">
              <a:lnSpc>
                <a:spcPct val="90000"/>
              </a:lnSpc>
              <a:spcBef>
                <a:spcPct val="0"/>
              </a:spcBef>
            </a:pPr>
            <a:r>
              <a:rPr lang="en-US" altLang="zh-CN" sz="6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edicted by AlphaFold2</a:t>
            </a:r>
            <a:endParaRPr lang="zh-CN" altLang="en-US" sz="6000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49255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627FC1E-A161-4D59-ACDF-AD710D7A8B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484063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5090BCE-A5C1-4D4D-B371-304EA0CB06C7}"/>
              </a:ext>
            </a:extLst>
          </p:cNvPr>
          <p:cNvSpPr txBox="1"/>
          <p:nvPr/>
        </p:nvSpPr>
        <p:spPr>
          <a:xfrm>
            <a:off x="0" y="5112482"/>
            <a:ext cx="1277815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nged in order in this figure are CYP6AB112-CYP6AB117, CYP6AN35, CYP6B74</a:t>
            </a:r>
            <a:endParaRPr lang="zh-CN" alt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1583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0FC5E40-2D8C-43E0-A7A3-EBE8560748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8675077" cy="427644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2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2624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3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4066589-93C2-4083-878A-B3D83BA893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9179505" cy="4525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3813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4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675F839-6785-4E04-B852-690EFCBFC1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1"/>
            <a:ext cx="8989255" cy="4431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3536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5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9C739C1-8222-4315-9A3A-76BC4B25BB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1"/>
            <a:ext cx="8323385" cy="41030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79953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6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5247321-4B89-43CE-8EEC-DEA0F7F9EB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608758" cy="4243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20139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243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B117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212E4A0-6C38-4197-94E3-24C1C7A8D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513634" cy="41968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69114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21F51F7-5D5C-4B40-B28F-8B9398201EEC}"/>
              </a:ext>
            </a:extLst>
          </p:cNvPr>
          <p:cNvSpPr txBox="1"/>
          <p:nvPr/>
        </p:nvSpPr>
        <p:spPr>
          <a:xfrm>
            <a:off x="1852247" y="5064369"/>
            <a:ext cx="35169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AN35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68FFB92-DD44-4F50-AE41-9B3F92B26F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751444" cy="4314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4246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1D7CF98-7A69-4EAB-8D6F-83B2006AED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8180697" cy="403273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DD3C634-D8EC-4EC7-87E3-1F17754438AD}"/>
              </a:ext>
            </a:extLst>
          </p:cNvPr>
          <p:cNvSpPr txBox="1"/>
          <p:nvPr/>
        </p:nvSpPr>
        <p:spPr>
          <a:xfrm>
            <a:off x="1852247" y="5064369"/>
            <a:ext cx="35169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6B74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253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8</Words>
  <Application>Microsoft Office PowerPoint</Application>
  <PresentationFormat>宽屏</PresentationFormat>
  <Paragraphs>12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等线</vt:lpstr>
      <vt:lpstr>等线 Light</vt:lpstr>
      <vt:lpstr>Arial</vt:lpstr>
      <vt:lpstr>Times New Roman</vt:lpstr>
      <vt:lpstr>Office 主题​​</vt:lpstr>
      <vt:lpstr>The prediction of these 8 genes by TMHMM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prediction of these 8 genes by TMHMM</dc:title>
  <dc:creator>Windows User</dc:creator>
  <cp:lastModifiedBy>Windows User</cp:lastModifiedBy>
  <cp:revision>2</cp:revision>
  <dcterms:created xsi:type="dcterms:W3CDTF">2022-03-03T14:05:23Z</dcterms:created>
  <dcterms:modified xsi:type="dcterms:W3CDTF">2022-03-03T14:14:51Z</dcterms:modified>
</cp:coreProperties>
</file>